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</p:sldMasterIdLst>
  <p:notesMasterIdLst>
    <p:notesMasterId r:id="rId4"/>
  </p:notesMasterIdLst>
  <p:sldIdLst>
    <p:sldId id="260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5" d="100"/>
          <a:sy n="65" d="100"/>
        </p:scale>
        <p:origin x="218" y="29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1A3FE04-7359-4000-B1DA-34FC828A73DE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B97D50-E410-4C9A-91AE-6B0B95C39BB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28942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CDB97D50-E410-4C9A-91AE-6B0B95C39BB8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360691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E78671F-D8A3-4460-81A2-B091F9AAF65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6208B23A-151B-4684-87E9-A8BA54ECDC4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BE9F663-E403-462E-BC30-DACD367376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2731EA-6C77-4B76-8D85-F6C988550D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CCB2CAC-12D1-4BF9-821D-4941D1053B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625238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26364E-71D6-4365-988D-CC4F0AC685B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98D4E80A-DFE0-4604-A70C-1EA1FB18FAE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6DCB373-513E-49F8-B0D8-4C96173BD32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68ED032-1E38-465C-9F4B-4B32385165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B0358F-C55A-440F-B366-0DFB0C9F95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67309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5E573449-6331-4EF3-8C38-C4C5EAFC25C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B809A3EB-4238-4A21-9BE5-454AE212A23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F63362F9-D134-4BE1-AA95-28BC7302A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9E9528C7-DEFE-4348-95F6-13D9958388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F0C44EF-AAC5-4F75-A11D-8FB5CAA854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9516344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4696612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966325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070495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195967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482119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3990997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04496442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66568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9B18A20-A987-4790-B2A6-D299E785091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06192F5-4755-48E9-9A85-5765A1FD661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26D264A-B5DF-4C60-9F84-4E0621CFA1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7E573CA-26B2-4EB1-9BE9-0DD7EEEB71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3C628AC-325C-4875-BECF-7EC445B1C4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42729785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4429100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057207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97066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F3CA68B-EFF8-42CE-8BE3-CD94B01ABA9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164B3D22-F89E-4971-B432-5A127B870B1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29A9DD0-7115-448D-9C34-A811C7DAEC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7BEDD5AE-4F03-44FE-AAC2-278B640934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6968148-FD66-4D0A-99E5-9B678337EF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4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65413C3-41C0-4F9F-91E6-3D87083215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10808F8-BD1A-41B7-9247-95271FA61F0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FC21E118-F8D9-48BE-A1CE-A123F143BDD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6A0751C-D6A3-4CCF-9BF5-1146D3FD6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260E609-C028-4FF1-9588-0A7B6ED033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57D70526-CEFD-4BE5-9EE3-B4E06268D4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223755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2D615A1-80D4-42D6-AFDE-E878C9B08D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B2066D00-E464-4461-88CB-10253DB9FA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0C379EC2-2D4C-4AC2-BA33-92815BB0E3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56CACC8C-F21C-46C4-9FE8-FBFFFA01FE4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4AFB1090-5B25-4506-AE03-0170593A33D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16A2CD9-EDDC-427F-8219-9563A44EE8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75A955E1-817A-411B-8A03-6C3D2A722B4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AB2430E9-7EC7-45B1-801E-DE2A15622D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660644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73AB7886-0DB2-4043-85A9-62FFD9DBFA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4A20541C-845D-4CF6-AB48-AC917916717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00939F27-3229-489A-8EE1-DCB73A2668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E8871558-8ADF-47CD-8376-2E8D678F86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3352360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0E600C1C-6812-42C5-B5E7-238D2C719F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258D7E7D-218A-4340-98A5-378EA9B82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B71CCFC9-A94B-4FD2-9A64-609D4BFDEA8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25598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0D0EE0E-2C28-4802-887E-E0309ED560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A99EB91D-309C-46E8-A715-A45601BBD13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9A72CFF-9847-4A65-9997-F63FB69337D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B203EE10-DF99-43DB-A08F-B0E89B1137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D98F9011-620D-4F5B-A5F7-B432DA5BE08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2896F9BE-C646-43F7-AACF-C67BBD58A9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468424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B94ACE9-835A-4304-8745-A01B2D80416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BE5B2E5B-7777-45FA-BD55-7891552E38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E9A31A1C-DAA6-42FC-B66A-81297538E1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95197CDC-A100-4705-AC15-A167304DE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77F09D85-BCC6-4676-BA94-7D3DAA3A9B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A63846CB-5D8E-433D-BA56-A03B13BB3A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301900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194BBFE1-50F9-473C-A048-9FB622175D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38512A04-753C-43C2-AEE2-390687C3683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C8EB0FC-2CD2-4146-A502-AE4268D76C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D7E94A-A3E6-41CE-8755-F6C4D3540C1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898C0CA-5DD7-4B46-B029-351614ECED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9043EBC8-4D72-4583-AB81-97276B6FEB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E6BBCC6-8CB5-4063-8194-8500B5C67113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1806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0/9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562857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3.xml"/><Relationship Id="rId5" Type="http://schemas.openxmlformats.org/officeDocument/2006/relationships/image" Target="../media/image2.jpe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9"/>
          <p:cNvSpPr txBox="1"/>
          <p:nvPr/>
        </p:nvSpPr>
        <p:spPr>
          <a:xfrm>
            <a:off x="6840728" y="3208409"/>
            <a:ext cx="97043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478"/>
            <a:r>
              <a:rPr lang="en-US" altLang="zh-CN" sz="900" b="1" dirty="0">
                <a:solidFill>
                  <a:prstClr val="white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5-D</a:t>
            </a:r>
            <a:endParaRPr lang="zh-CN" altLang="en-US" sz="900" b="1" dirty="0">
              <a:solidFill>
                <a:prstClr val="white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05563A61-CF90-4B7A-AADE-E92D1F46F32A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hqprint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13000" contrast="41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655" t="17937" r="50157" b="8401"/>
          <a:stretch/>
        </p:blipFill>
        <p:spPr>
          <a:xfrm>
            <a:off x="7063610" y="1397013"/>
            <a:ext cx="2692192" cy="3082234"/>
          </a:xfrm>
          <a:prstGeom prst="rect">
            <a:avLst/>
          </a:prstGeom>
        </p:spPr>
      </p:pic>
      <p:sp>
        <p:nvSpPr>
          <p:cNvPr id="12" name="TextBox 4">
            <a:extLst>
              <a:ext uri="{FF2B5EF4-FFF2-40B4-BE49-F238E27FC236}">
                <a16:creationId xmlns:a16="http://schemas.microsoft.com/office/drawing/2014/main" id="{E566212B-4A58-4192-BFBA-CEA46872C469}"/>
              </a:ext>
            </a:extLst>
          </p:cNvPr>
          <p:cNvSpPr txBox="1"/>
          <p:nvPr/>
        </p:nvSpPr>
        <p:spPr>
          <a:xfrm>
            <a:off x="7188834" y="2023653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white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42-B</a:t>
            </a:r>
            <a:endParaRPr lang="zh-CN" altLang="en-US" sz="1200" b="1" dirty="0">
              <a:solidFill>
                <a:prstClr val="white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4" name="TextBox 5">
            <a:extLst>
              <a:ext uri="{FF2B5EF4-FFF2-40B4-BE49-F238E27FC236}">
                <a16:creationId xmlns:a16="http://schemas.microsoft.com/office/drawing/2014/main" id="{DEAD79D4-6BC8-46FB-8E59-DA10653F8B5A}"/>
              </a:ext>
            </a:extLst>
          </p:cNvPr>
          <p:cNvSpPr txBox="1"/>
          <p:nvPr/>
        </p:nvSpPr>
        <p:spPr>
          <a:xfrm>
            <a:off x="8682209" y="2232268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white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5-D</a:t>
            </a:r>
            <a:endParaRPr lang="zh-CN" altLang="en-US" sz="1200" b="1" dirty="0">
              <a:solidFill>
                <a:prstClr val="white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18" name="TextBox 7">
            <a:extLst>
              <a:ext uri="{FF2B5EF4-FFF2-40B4-BE49-F238E27FC236}">
                <a16:creationId xmlns:a16="http://schemas.microsoft.com/office/drawing/2014/main" id="{C3099DFE-0874-4FDC-9531-D2FF44F20E68}"/>
              </a:ext>
            </a:extLst>
          </p:cNvPr>
          <p:cNvSpPr txBox="1"/>
          <p:nvPr/>
        </p:nvSpPr>
        <p:spPr>
          <a:xfrm>
            <a:off x="8602166" y="3739663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white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BKT7</a:t>
            </a:r>
            <a:endParaRPr lang="zh-CN" altLang="en-US" sz="1200" b="1" dirty="0">
              <a:solidFill>
                <a:prstClr val="white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0" name="TextBox 13">
            <a:extLst>
              <a:ext uri="{FF2B5EF4-FFF2-40B4-BE49-F238E27FC236}">
                <a16:creationId xmlns:a16="http://schemas.microsoft.com/office/drawing/2014/main" id="{EF635F31-E83A-4413-9852-70E38FB89480}"/>
              </a:ext>
            </a:extLst>
          </p:cNvPr>
          <p:cNvSpPr txBox="1"/>
          <p:nvPr/>
        </p:nvSpPr>
        <p:spPr>
          <a:xfrm>
            <a:off x="7063610" y="3481289"/>
            <a:ext cx="13681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prstClr val="white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NAC6</a:t>
            </a:r>
            <a:endParaRPr lang="zh-CN" altLang="en-US" sz="1200" b="1" dirty="0">
              <a:solidFill>
                <a:prstClr val="white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pic>
        <p:nvPicPr>
          <p:cNvPr id="34" name="图片 33">
            <a:extLst>
              <a:ext uri="{FF2B5EF4-FFF2-40B4-BE49-F238E27FC236}">
                <a16:creationId xmlns:a16="http://schemas.microsoft.com/office/drawing/2014/main" id="{6DB2C6E6-658F-4B7A-9278-F8408EA5EA2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20" t="8897" r="15050" b="8633"/>
          <a:stretch/>
        </p:blipFill>
        <p:spPr>
          <a:xfrm>
            <a:off x="1376453" y="1437891"/>
            <a:ext cx="3030456" cy="3041356"/>
          </a:xfrm>
          <a:prstGeom prst="rect">
            <a:avLst/>
          </a:prstGeom>
        </p:spPr>
      </p:pic>
      <p:sp>
        <p:nvSpPr>
          <p:cNvPr id="36" name="TextBox 4">
            <a:extLst>
              <a:ext uri="{FF2B5EF4-FFF2-40B4-BE49-F238E27FC236}">
                <a16:creationId xmlns:a16="http://schemas.microsoft.com/office/drawing/2014/main" id="{8B592F14-BFB8-4DC1-81B7-ADB061BFA899}"/>
              </a:ext>
            </a:extLst>
          </p:cNvPr>
          <p:cNvSpPr txBox="1"/>
          <p:nvPr/>
        </p:nvSpPr>
        <p:spPr>
          <a:xfrm>
            <a:off x="723184" y="1207059"/>
            <a:ext cx="232727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78"/>
            <a:r>
              <a:rPr lang="en-US" altLang="zh-CN" sz="10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SD/-</a:t>
            </a:r>
            <a:r>
              <a:rPr lang="en-US" altLang="zh-CN" sz="1000" b="1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rp</a:t>
            </a:r>
            <a:r>
              <a:rPr lang="en-US" altLang="zh-CN" sz="10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-His-</a:t>
            </a:r>
            <a:r>
              <a:rPr lang="en-US" altLang="zh-CN" sz="1000" b="1" dirty="0" err="1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Leu</a:t>
            </a:r>
            <a:endParaRPr lang="zh-CN" altLang="en-US" sz="1000" b="1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38" name="TextBox 9">
            <a:extLst>
              <a:ext uri="{FF2B5EF4-FFF2-40B4-BE49-F238E27FC236}">
                <a16:creationId xmlns:a16="http://schemas.microsoft.com/office/drawing/2014/main" id="{366EF3AF-552B-42F3-BFB2-5D74F2D9A04B}"/>
              </a:ext>
            </a:extLst>
          </p:cNvPr>
          <p:cNvSpPr txBox="1"/>
          <p:nvPr/>
        </p:nvSpPr>
        <p:spPr>
          <a:xfrm>
            <a:off x="3269240" y="1455711"/>
            <a:ext cx="115522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478"/>
            <a:r>
              <a:rPr lang="en-US" altLang="zh-CN" sz="1000" b="1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42-B</a:t>
            </a:r>
            <a:endParaRPr lang="zh-CN" altLang="en-US" sz="1000" b="1" dirty="0">
              <a:solidFill>
                <a:schemeClr val="bg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0" name="矩形 39">
            <a:extLst>
              <a:ext uri="{FF2B5EF4-FFF2-40B4-BE49-F238E27FC236}">
                <a16:creationId xmlns:a16="http://schemas.microsoft.com/office/drawing/2014/main" id="{440CBAA6-56D4-463B-ADAE-79FD385834B4}"/>
              </a:ext>
            </a:extLst>
          </p:cNvPr>
          <p:cNvSpPr/>
          <p:nvPr/>
        </p:nvSpPr>
        <p:spPr>
          <a:xfrm>
            <a:off x="1376454" y="1471100"/>
            <a:ext cx="740908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78"/>
            <a:r>
              <a:rPr lang="en-US" altLang="zh-CN" sz="1000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CN" sz="1000" b="1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NAC6</a:t>
            </a:r>
            <a:r>
              <a:rPr lang="en-US" altLang="zh-CN" sz="1000" b="1" i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</a:t>
            </a:r>
            <a:endParaRPr lang="zh-CN" altLang="en-US" sz="1000" b="1" dirty="0">
              <a:solidFill>
                <a:prstClr val="black"/>
              </a:solidFill>
              <a:latin typeface="Calibri"/>
              <a:ea typeface="宋体" panose="02010600030101010101" pitchFamily="2" charset="-122"/>
            </a:endParaRPr>
          </a:p>
        </p:txBody>
      </p:sp>
      <p:sp>
        <p:nvSpPr>
          <p:cNvPr id="42" name="矩形 41">
            <a:extLst>
              <a:ext uri="{FF2B5EF4-FFF2-40B4-BE49-F238E27FC236}">
                <a16:creationId xmlns:a16="http://schemas.microsoft.com/office/drawing/2014/main" id="{5BA7A5F1-6B4F-4BE3-BB49-52A3BA917301}"/>
              </a:ext>
            </a:extLst>
          </p:cNvPr>
          <p:cNvSpPr/>
          <p:nvPr/>
        </p:nvSpPr>
        <p:spPr>
          <a:xfrm>
            <a:off x="1376452" y="4114392"/>
            <a:ext cx="688009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defTabSz="914478"/>
            <a:r>
              <a:rPr lang="en-US" altLang="zh-CN" sz="1000" b="1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pGBKT7</a:t>
            </a:r>
            <a:endParaRPr lang="zh-CN" altLang="en-US" sz="1000" b="1" dirty="0">
              <a:solidFill>
                <a:schemeClr val="bg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4" name="TextBox 9">
            <a:extLst>
              <a:ext uri="{FF2B5EF4-FFF2-40B4-BE49-F238E27FC236}">
                <a16:creationId xmlns:a16="http://schemas.microsoft.com/office/drawing/2014/main" id="{0F88CDEE-A6FC-432A-93A3-8D9BFA47B336}"/>
              </a:ext>
            </a:extLst>
          </p:cNvPr>
          <p:cNvSpPr txBox="1"/>
          <p:nvPr/>
        </p:nvSpPr>
        <p:spPr>
          <a:xfrm>
            <a:off x="3500153" y="4148173"/>
            <a:ext cx="97043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 defTabSz="914478"/>
            <a:r>
              <a:rPr lang="en-US" altLang="zh-CN" sz="1000" b="1" dirty="0">
                <a:solidFill>
                  <a:schemeClr val="bg1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TaWRKY5-D</a:t>
            </a:r>
            <a:endParaRPr lang="zh-CN" altLang="en-US" sz="1000" b="1" dirty="0">
              <a:solidFill>
                <a:schemeClr val="bg1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6" name="TextBox 1">
            <a:extLst>
              <a:ext uri="{FF2B5EF4-FFF2-40B4-BE49-F238E27FC236}">
                <a16:creationId xmlns:a16="http://schemas.microsoft.com/office/drawing/2014/main" id="{AAA6B614-0212-45F8-968C-18A2F252270C}"/>
              </a:ext>
            </a:extLst>
          </p:cNvPr>
          <p:cNvSpPr txBox="1"/>
          <p:nvPr/>
        </p:nvSpPr>
        <p:spPr>
          <a:xfrm>
            <a:off x="1026513" y="1000525"/>
            <a:ext cx="18864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78"/>
            <a:r>
              <a:rPr lang="en-US" altLang="zh-CN" sz="16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a</a:t>
            </a:r>
            <a:endParaRPr lang="zh-CN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48" name="TextBox 2">
            <a:extLst>
              <a:ext uri="{FF2B5EF4-FFF2-40B4-BE49-F238E27FC236}">
                <a16:creationId xmlns:a16="http://schemas.microsoft.com/office/drawing/2014/main" id="{755F8AF8-316A-4231-9230-290BC1152356}"/>
              </a:ext>
            </a:extLst>
          </p:cNvPr>
          <p:cNvSpPr txBox="1"/>
          <p:nvPr/>
        </p:nvSpPr>
        <p:spPr>
          <a:xfrm>
            <a:off x="6510253" y="1037782"/>
            <a:ext cx="29442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78"/>
            <a:r>
              <a:rPr lang="en-US" altLang="zh-CN" sz="1600" b="1" dirty="0">
                <a:solidFill>
                  <a:prstClr val="black"/>
                </a:solidFill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b</a:t>
            </a:r>
            <a:endParaRPr lang="zh-CN" altLang="en-US" sz="1600" b="1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0" name="TextBox 25">
            <a:extLst>
              <a:ext uri="{FF2B5EF4-FFF2-40B4-BE49-F238E27FC236}">
                <a16:creationId xmlns:a16="http://schemas.microsoft.com/office/drawing/2014/main" id="{2A2F5B91-8A60-4D2B-A854-757613EA3980}"/>
              </a:ext>
            </a:extLst>
          </p:cNvPr>
          <p:cNvSpPr txBox="1"/>
          <p:nvPr/>
        </p:nvSpPr>
        <p:spPr>
          <a:xfrm>
            <a:off x="443313" y="299984"/>
            <a:ext cx="2304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78"/>
            <a:r>
              <a:rPr lang="en-US" altLang="zh-CN" sz="1600" kern="100" dirty="0">
                <a:solidFill>
                  <a:prstClr val="black"/>
                </a:solidFill>
                <a:latin typeface="Times New Roman"/>
                <a:ea typeface="宋体" panose="02010600030101010101" pitchFamily="2" charset="-122"/>
              </a:rPr>
              <a:t>Additional file 3: Fig. S3</a:t>
            </a:r>
            <a:endParaRPr lang="zh-CN" altLang="en-US" sz="1600" dirty="0">
              <a:solidFill>
                <a:prstClr val="black"/>
              </a:solidFill>
              <a:latin typeface="Times New Roman" panose="02020603050405020304" pitchFamily="18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51" name="矩形 50">
            <a:extLst>
              <a:ext uri="{FF2B5EF4-FFF2-40B4-BE49-F238E27FC236}">
                <a16:creationId xmlns:a16="http://schemas.microsoft.com/office/drawing/2014/main" id="{6FC5798C-B4B0-48A2-95E5-18319868D789}"/>
              </a:ext>
            </a:extLst>
          </p:cNvPr>
          <p:cNvSpPr/>
          <p:nvPr/>
        </p:nvSpPr>
        <p:spPr>
          <a:xfrm>
            <a:off x="1260231" y="5015371"/>
            <a:ext cx="10351666" cy="57708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defTabSz="457200"/>
            <a:r>
              <a:rPr lang="en-US" altLang="zh-CN" sz="1050" b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3: Fig. S3 TaWRKY42-B possesses transcriptional activity in yeast. </a:t>
            </a:r>
            <a:endParaRPr lang="zh-CN" altLang="zh-CN" sz="1050" kern="100" dirty="0">
              <a:solidFill>
                <a:prstClr val="black"/>
              </a:solidFill>
              <a:cs typeface="Times New Roman" panose="02020603050405020304" pitchFamily="18" charset="0"/>
            </a:endParaRPr>
          </a:p>
          <a:p>
            <a:pPr marL="228600" indent="-228600" algn="just" defTabSz="457200">
              <a:buAutoNum type="alphaLcParenBoth"/>
            </a:pPr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Yeast strains containing the indicated vectors were grown on SD/-</a:t>
            </a:r>
            <a:r>
              <a:rPr lang="en-US" altLang="zh-CN" sz="1050" kern="100" dirty="0" err="1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rp</a:t>
            </a:r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-His-Leu medium. The strain contained  pGBKT7</a:t>
            </a:r>
            <a:r>
              <a:rPr lang="en-US" altLang="zh-CN" sz="1050" i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vector as the negative control. </a:t>
            </a:r>
            <a:r>
              <a:rPr lang="en-US" altLang="zh-CN" sz="1050" i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NAC6 </a:t>
            </a:r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d </a:t>
            </a:r>
            <a:r>
              <a:rPr lang="en-US" altLang="zh-CN" sz="1050" i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aWRKY5-D</a:t>
            </a:r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were </a:t>
            </a:r>
          </a:p>
          <a:p>
            <a:pPr algn="just" defTabSz="457200"/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fused to pGBKT7</a:t>
            </a:r>
            <a:r>
              <a:rPr lang="en-US" altLang="zh-CN" sz="1050" i="1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zh-CN" sz="1050" kern="1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 the positive control. (b) The above yeast colonies were analyzed by X-gal staining.</a:t>
            </a:r>
            <a:endParaRPr lang="zh-CN" altLang="zh-CN" sz="1050" kern="100" dirty="0">
              <a:solidFill>
                <a:prstClr val="black"/>
              </a:solidFill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06453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3</TotalTime>
  <Words>86</Words>
  <Application>Microsoft Office PowerPoint</Application>
  <PresentationFormat>宽屏</PresentationFormat>
  <Paragraphs>17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2</vt:i4>
      </vt:variant>
      <vt:variant>
        <vt:lpstr>幻灯片标题</vt:lpstr>
      </vt:variant>
      <vt:variant>
        <vt:i4>1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Times New Roman</vt:lpstr>
      <vt:lpstr>Office 主题​​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王 耕</dc:creator>
  <cp:lastModifiedBy>王 耕</cp:lastModifiedBy>
  <cp:revision>10</cp:revision>
  <dcterms:created xsi:type="dcterms:W3CDTF">2020-08-23T07:40:15Z</dcterms:created>
  <dcterms:modified xsi:type="dcterms:W3CDTF">2020-09-01T12:28:53Z</dcterms:modified>
</cp:coreProperties>
</file>